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77" r:id="rId2"/>
    <p:sldId id="274" r:id="rId3"/>
    <p:sldId id="264" r:id="rId4"/>
    <p:sldId id="278" r:id="rId5"/>
    <p:sldId id="276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160"/>
    <p:restoredTop sz="94663"/>
  </p:normalViewPr>
  <p:slideViewPr>
    <p:cSldViewPr snapToGrid="0" snapToObjects="1">
      <p:cViewPr varScale="1">
        <p:scale>
          <a:sx n="88" d="100"/>
          <a:sy n="88" d="100"/>
        </p:scale>
        <p:origin x="31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marius Waller" userId="f11cb600-58f3-4271-8737-0d932030c3f2" providerId="ADAL" clId="{4E436B17-D896-BB4E-9634-778758548887}"/>
    <pc:docChg chg="delSld">
      <pc:chgData name="Jamarius Waller" userId="f11cb600-58f3-4271-8737-0d932030c3f2" providerId="ADAL" clId="{4E436B17-D896-BB4E-9634-778758548887}" dt="2021-02-15T15:26:12.125" v="0" actId="2696"/>
      <pc:docMkLst>
        <pc:docMk/>
      </pc:docMkLst>
      <pc:sldChg chg="del">
        <pc:chgData name="Jamarius Waller" userId="f11cb600-58f3-4271-8737-0d932030c3f2" providerId="ADAL" clId="{4E436B17-D896-BB4E-9634-778758548887}" dt="2021-02-15T15:26:12.125" v="0" actId="2696"/>
        <pc:sldMkLst>
          <pc:docMk/>
          <pc:sldMk cId="1699172903" sldId="27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9A0FC3-42F2-EB4A-8229-DAD73338DDCF}" type="datetimeFigureOut">
              <a:rPr lang="en-US" smtClean="0"/>
              <a:t>2/15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ECE6D7-4886-2643-A48B-18010850C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982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ECE6D7-4886-2643-A48B-18010850CE8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5184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291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554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001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138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809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192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526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36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67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534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234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382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microsoft.com/office/2007/relationships/hdphoto" Target="../media/hdphoto2.wdp"/><Relationship Id="rId4" Type="http://schemas.openxmlformats.org/officeDocument/2006/relationships/image" Target="../media/image13.png"/><Relationship Id="rId9" Type="http://schemas.microsoft.com/office/2007/relationships/hdphoto" Target="../media/hdphoto4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29CA480-96E7-FC4E-A355-89B15B8E42E3}"/>
              </a:ext>
            </a:extLst>
          </p:cNvPr>
          <p:cNvSpPr/>
          <p:nvPr/>
        </p:nvSpPr>
        <p:spPr>
          <a:xfrm>
            <a:off x="0" y="998464"/>
            <a:ext cx="6858000" cy="34180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ose-Escalating Toxicology of the Candidate Biologic ELP-VEGF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mariu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. Waller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Stephen P. Burke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Jason Engel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Alejandro R. Chade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,4,5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Gene L. Bidwell, III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,2,6,*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partment of Pharmacology and Toxicolog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partment of Neurolog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partment of Physiology and Biophysics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epartment of Medicine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5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epartment of Radiolog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partment of Cell and Molecular Biolog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University of Mississippi Medical Center, 2500 North State Street, Jackson, MS. 39216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828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F58F72A-D85B-B54A-B0C8-285FAFC09D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021" y="597275"/>
            <a:ext cx="3580654" cy="239205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1133F99-2AEF-EB4E-A11C-B883984CE5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567560"/>
            <a:ext cx="3654941" cy="242177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D5A3ED4-5FF0-6D4C-8952-0991058B71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021" y="2989330"/>
            <a:ext cx="3341979" cy="22151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40B3E6C-6028-D241-9977-A1BB7E6F2DC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9000" y="2989330"/>
            <a:ext cx="3341979" cy="221337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07A66C9-F5D7-E045-88E6-F41DCA23D945}"/>
              </a:ext>
            </a:extLst>
          </p:cNvPr>
          <p:cNvSpPr txBox="1"/>
          <p:nvPr/>
        </p:nvSpPr>
        <p:spPr>
          <a:xfrm>
            <a:off x="-6561" y="469112"/>
            <a:ext cx="3193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7AD0A9E-F43E-D04F-AFFF-3E81DD1B0D2F}"/>
              </a:ext>
            </a:extLst>
          </p:cNvPr>
          <p:cNvSpPr txBox="1"/>
          <p:nvPr/>
        </p:nvSpPr>
        <p:spPr>
          <a:xfrm>
            <a:off x="3288254" y="469112"/>
            <a:ext cx="309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ECEED6E-BD37-C249-9479-73CF497B16DD}"/>
              </a:ext>
            </a:extLst>
          </p:cNvPr>
          <p:cNvSpPr txBox="1"/>
          <p:nvPr/>
        </p:nvSpPr>
        <p:spPr>
          <a:xfrm>
            <a:off x="3284058" y="2954177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4A7140-765D-1843-B605-57267984DD3F}"/>
              </a:ext>
            </a:extLst>
          </p:cNvPr>
          <p:cNvSpPr txBox="1"/>
          <p:nvPr/>
        </p:nvSpPr>
        <p:spPr>
          <a:xfrm>
            <a:off x="-6561" y="2954177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69D2272-630A-8743-8A1A-45F3FE2F772E}"/>
              </a:ext>
            </a:extLst>
          </p:cNvPr>
          <p:cNvSpPr txBox="1"/>
          <p:nvPr/>
        </p:nvSpPr>
        <p:spPr>
          <a:xfrm>
            <a:off x="-6561" y="5381158"/>
            <a:ext cx="677097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Temperature-induced Phase Transition of ELP-VEGF.  The coacervation of ELP-VEGF was determined as a function of its concentration from 1 to 100 µM in physiological saline buffer (a and b).  The transition temperature was defined as the maximum in a plot of the first derivative of the aggregation profile.  The transition temperature was also determined across the range of osmolarity likely to be experienced by ELP-VEGF as it traffics through the renal tubules using a range of sodium chloride concentrations between 25 and 700 mM in phosphate buffer (c and d, dashed line marks 37 </a:t>
            </a:r>
            <a:r>
              <a:rPr 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∘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body temperature).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13010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8953533-BCE3-6A47-9C95-751B921AD4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1439" y="4521620"/>
            <a:ext cx="2553419" cy="226676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628E1D2-8C08-7D47-AFFB-50B611CA7B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129" y="2344722"/>
            <a:ext cx="2553419" cy="217689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E694901-4264-8841-8E8F-B96BD3CACA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91439" y="2344722"/>
            <a:ext cx="2553419" cy="215498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C6BFCDC-4C9A-5F4A-94E3-E1BB9FE847D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129" y="4625716"/>
            <a:ext cx="2553419" cy="213350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D1B6332-BED9-1141-89FC-0229F13EDBF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129" y="6863317"/>
            <a:ext cx="2557703" cy="215498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219A0E02-8368-9A4B-8698-ACBF7E101FC3}"/>
              </a:ext>
            </a:extLst>
          </p:cNvPr>
          <p:cNvSpPr txBox="1"/>
          <p:nvPr/>
        </p:nvSpPr>
        <p:spPr>
          <a:xfrm>
            <a:off x="-39882" y="5777"/>
            <a:ext cx="3193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2DFBF87-3E8F-B645-8F3D-2EE44CC7E260}"/>
              </a:ext>
            </a:extLst>
          </p:cNvPr>
          <p:cNvSpPr txBox="1"/>
          <p:nvPr/>
        </p:nvSpPr>
        <p:spPr>
          <a:xfrm>
            <a:off x="-39882" y="2264856"/>
            <a:ext cx="309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5F92A4-1897-664E-B197-DCA7314835FE}"/>
              </a:ext>
            </a:extLst>
          </p:cNvPr>
          <p:cNvSpPr txBox="1"/>
          <p:nvPr/>
        </p:nvSpPr>
        <p:spPr>
          <a:xfrm>
            <a:off x="2582548" y="2264856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250AE86-D5DC-A54A-927F-2800DCEA08BF}"/>
              </a:ext>
            </a:extLst>
          </p:cNvPr>
          <p:cNvSpPr txBox="1"/>
          <p:nvPr/>
        </p:nvSpPr>
        <p:spPr>
          <a:xfrm>
            <a:off x="-31231" y="4499705"/>
            <a:ext cx="309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2A4F654-130D-4A45-BEE7-13ECD5647953}"/>
              </a:ext>
            </a:extLst>
          </p:cNvPr>
          <p:cNvSpPr txBox="1"/>
          <p:nvPr/>
        </p:nvSpPr>
        <p:spPr>
          <a:xfrm>
            <a:off x="2582548" y="4499705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929D79E-3B26-1647-861A-FBAF082FDDB6}"/>
              </a:ext>
            </a:extLst>
          </p:cNvPr>
          <p:cNvSpPr txBox="1"/>
          <p:nvPr/>
        </p:nvSpPr>
        <p:spPr>
          <a:xfrm>
            <a:off x="-44055" y="6763877"/>
            <a:ext cx="3193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9DDE8136-1817-3C43-88BB-72F95FF5F84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51559" y="11686"/>
            <a:ext cx="2698531" cy="226676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5FC142A8-A970-2443-9407-90246B05A06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129" y="109575"/>
            <a:ext cx="2553419" cy="214487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05D4A9E-4F9F-124A-A8AC-10E396AEE3FF}"/>
              </a:ext>
            </a:extLst>
          </p:cNvPr>
          <p:cNvSpPr txBox="1"/>
          <p:nvPr/>
        </p:nvSpPr>
        <p:spPr>
          <a:xfrm>
            <a:off x="2691439" y="7328118"/>
            <a:ext cx="4064222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Plasma Markers of Renal and Liver Injury.  Plasma samples collected on Day 14 after ELP-VEGF injection were assessed for markers of renal and liver function and injury using a Vet AXCEL chemistry analyzer.  *  p &lt; 0.05, one-way ANOVA with post-hoc Dunnett correction for multiple comparisons.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857A582-A217-E24F-8B96-BD9BA009599E}"/>
              </a:ext>
            </a:extLst>
          </p:cNvPr>
          <p:cNvSpPr txBox="1"/>
          <p:nvPr/>
        </p:nvSpPr>
        <p:spPr>
          <a:xfrm>
            <a:off x="2582548" y="11686"/>
            <a:ext cx="328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17012290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F04CDB04-84BC-944C-8977-1802FC1C18DB}"/>
              </a:ext>
            </a:extLst>
          </p:cNvPr>
          <p:cNvSpPr/>
          <p:nvPr/>
        </p:nvSpPr>
        <p:spPr>
          <a:xfrm>
            <a:off x="43509" y="150305"/>
            <a:ext cx="6848719" cy="613562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A2061F2-C576-654A-9552-37D1090828C4}"/>
              </a:ext>
            </a:extLst>
          </p:cNvPr>
          <p:cNvSpPr txBox="1"/>
          <p:nvPr/>
        </p:nvSpPr>
        <p:spPr>
          <a:xfrm>
            <a:off x="43510" y="6370538"/>
            <a:ext cx="677097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ELP-VEGF on Tumor Vascular Density in Nude Mice.  Tumor vascular density in nude mice bearing MDA-MB-231 breast tumors was assessed five weeks after a single bolus ELP-VEGF injection at increasing doses by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C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anning (a.  Three-dimensional reconstruction; b. Two-dimensional slices through the tumor core in each of three planes, scale bar = 1 mm).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30F840C-E8D3-8F4F-A695-B2EE46047DFC}"/>
              </a:ext>
            </a:extLst>
          </p:cNvPr>
          <p:cNvSpPr txBox="1"/>
          <p:nvPr/>
        </p:nvSpPr>
        <p:spPr>
          <a:xfrm>
            <a:off x="593068" y="126772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4A4227-1AB3-134D-830E-7F00730BC94C}"/>
              </a:ext>
            </a:extLst>
          </p:cNvPr>
          <p:cNvSpPr txBox="1"/>
          <p:nvPr/>
        </p:nvSpPr>
        <p:spPr>
          <a:xfrm>
            <a:off x="2082009" y="126772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1 mg/k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427ECA7-D755-A347-A519-F534343D4F69}"/>
              </a:ext>
            </a:extLst>
          </p:cNvPr>
          <p:cNvSpPr txBox="1"/>
          <p:nvPr/>
        </p:nvSpPr>
        <p:spPr>
          <a:xfrm>
            <a:off x="3751700" y="126772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mg/k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FD1D99D-8634-F445-B8D9-52994813FC97}"/>
              </a:ext>
            </a:extLst>
          </p:cNvPr>
          <p:cNvSpPr txBox="1"/>
          <p:nvPr/>
        </p:nvSpPr>
        <p:spPr>
          <a:xfrm>
            <a:off x="5483447" y="12677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mg/kg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CFFB387-3C78-724C-BC78-24856F7199E5}"/>
              </a:ext>
            </a:extLst>
          </p:cNvPr>
          <p:cNvSpPr txBox="1"/>
          <p:nvPr/>
        </p:nvSpPr>
        <p:spPr>
          <a:xfrm>
            <a:off x="69009" y="1987383"/>
            <a:ext cx="343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65DCF21-CAEE-7343-9403-9C343606705A}"/>
              </a:ext>
            </a:extLst>
          </p:cNvPr>
          <p:cNvSpPr txBox="1"/>
          <p:nvPr/>
        </p:nvSpPr>
        <p:spPr>
          <a:xfrm>
            <a:off x="69009" y="113673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7C88C5D8-D7BF-1F47-B1DD-F1316496450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8475" t="22717" r="57120" b="50696"/>
          <a:stretch/>
        </p:blipFill>
        <p:spPr>
          <a:xfrm>
            <a:off x="365052" y="411486"/>
            <a:ext cx="1394361" cy="13943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30B8AC1-C877-3A4D-8412-B7FD759371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54995" t="21768" r="12325" b="51646"/>
          <a:stretch/>
        </p:blipFill>
        <p:spPr>
          <a:xfrm>
            <a:off x="437872" y="1919052"/>
            <a:ext cx="1324457" cy="13943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36925761-817F-6E4E-91A5-390A1D984A5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9102" t="52417" r="57423" b="23041"/>
          <a:stretch/>
        </p:blipFill>
        <p:spPr>
          <a:xfrm>
            <a:off x="437872" y="3397278"/>
            <a:ext cx="1356699" cy="12871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6548C947-09F7-A44E-A5C6-C5790BAA863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54984" t="52503" r="11541" b="23630"/>
          <a:stretch/>
        </p:blipFill>
        <p:spPr>
          <a:xfrm>
            <a:off x="514072" y="4854809"/>
            <a:ext cx="1356699" cy="1251799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D1F28F3-39A3-D44D-92BB-E273D3EF2C86}"/>
              </a:ext>
            </a:extLst>
          </p:cNvPr>
          <p:cNvCxnSpPr>
            <a:cxnSpLocks/>
          </p:cNvCxnSpPr>
          <p:nvPr/>
        </p:nvCxnSpPr>
        <p:spPr>
          <a:xfrm>
            <a:off x="6733067" y="6112530"/>
            <a:ext cx="81422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" name="Picture 46">
            <a:extLst>
              <a:ext uri="{FF2B5EF4-FFF2-40B4-BE49-F238E27FC236}">
                <a16:creationId xmlns:a16="http://schemas.microsoft.com/office/drawing/2014/main" id="{F91552F9-BC43-1A4A-AB0F-F9F3B6A77C1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1738" t="16424" r="48547" b="52016"/>
          <a:stretch/>
        </p:blipFill>
        <p:spPr>
          <a:xfrm>
            <a:off x="1935605" y="483637"/>
            <a:ext cx="1388843" cy="14283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3748042C-28D9-A341-9944-37565DBC3BA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58588" t="20958" r="12234" b="56460"/>
          <a:stretch/>
        </p:blipFill>
        <p:spPr>
          <a:xfrm>
            <a:off x="2117682" y="1961802"/>
            <a:ext cx="1020353" cy="10219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7C24C5FA-499C-E24A-A672-6C8351B622D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8665" t="50670" r="52997" b="15878"/>
          <a:stretch/>
        </p:blipFill>
        <p:spPr>
          <a:xfrm>
            <a:off x="2132352" y="3058083"/>
            <a:ext cx="991014" cy="15139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09B99056-E382-9947-8259-18475712AB8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58253" t="50853" r="13409" b="16210"/>
          <a:stretch/>
        </p:blipFill>
        <p:spPr>
          <a:xfrm>
            <a:off x="2068852" y="4659216"/>
            <a:ext cx="991014" cy="14905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7A1BF993-7A24-C547-AB3D-A9EA194716D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9615" t="19881" r="52020" b="50985"/>
          <a:stretch/>
        </p:blipFill>
        <p:spPr>
          <a:xfrm>
            <a:off x="3515045" y="469222"/>
            <a:ext cx="1403417" cy="1379244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2AF69A4C-6678-9D48-BB3C-FFBF640CC24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52829" t="19777" r="14779" b="53950"/>
          <a:stretch/>
        </p:blipFill>
        <p:spPr>
          <a:xfrm>
            <a:off x="3552289" y="1941372"/>
            <a:ext cx="1184917" cy="1243765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0E4747AC-E994-5E46-93EE-F61BD2613C6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0075" t="50635" r="56389" b="19575"/>
          <a:stretch/>
        </p:blipFill>
        <p:spPr>
          <a:xfrm>
            <a:off x="3629351" y="3274196"/>
            <a:ext cx="1226785" cy="1410270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4CCAF301-6FE8-5846-9B6C-0D4D10D662A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53219" t="50397" r="13245" b="19725"/>
          <a:stretch/>
        </p:blipFill>
        <p:spPr>
          <a:xfrm>
            <a:off x="3489651" y="4754875"/>
            <a:ext cx="1226785" cy="1414403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19BAB2EB-4B0B-C749-84E3-C9536171726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1179" t="11418" r="58950" b="45459"/>
          <a:stretch/>
        </p:blipFill>
        <p:spPr>
          <a:xfrm>
            <a:off x="5151460" y="421450"/>
            <a:ext cx="1449823" cy="16173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ED32A9AE-5BF1-154D-AA2B-B85F1F9E91D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51310" t="5701" r="18819" b="65017"/>
          <a:stretch/>
        </p:blipFill>
        <p:spPr>
          <a:xfrm>
            <a:off x="5151459" y="2030938"/>
            <a:ext cx="1449823" cy="10982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5BD2EEE4-B28A-B749-B83B-0759287431E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10897" t="56667" r="66998" b="6404"/>
          <a:stretch/>
        </p:blipFill>
        <p:spPr>
          <a:xfrm>
            <a:off x="5371058" y="3227985"/>
            <a:ext cx="1072908" cy="13849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82F2B6D0-7F1A-E44A-BD5C-BB68FC41CAE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51360" t="56682" r="20579" b="6389"/>
          <a:stretch/>
        </p:blipFill>
        <p:spPr>
          <a:xfrm>
            <a:off x="5150307" y="4808680"/>
            <a:ext cx="1362009" cy="138499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E4D441DE-7D9D-4D47-AC76-C3624C4C5501}"/>
              </a:ext>
            </a:extLst>
          </p:cNvPr>
          <p:cNvCxnSpPr/>
          <p:nvPr/>
        </p:nvCxnSpPr>
        <p:spPr>
          <a:xfrm>
            <a:off x="1870771" y="113673"/>
            <a:ext cx="64834" cy="617225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2C650542-216E-4348-B822-5C9092071A54}"/>
              </a:ext>
            </a:extLst>
          </p:cNvPr>
          <p:cNvCxnSpPr/>
          <p:nvPr/>
        </p:nvCxnSpPr>
        <p:spPr>
          <a:xfrm>
            <a:off x="3343971" y="100973"/>
            <a:ext cx="64834" cy="617225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80282790-E2BA-FB4F-9A51-9ABEF232316F}"/>
              </a:ext>
            </a:extLst>
          </p:cNvPr>
          <p:cNvCxnSpPr/>
          <p:nvPr/>
        </p:nvCxnSpPr>
        <p:spPr>
          <a:xfrm>
            <a:off x="5007671" y="126373"/>
            <a:ext cx="64834" cy="617225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19421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C006395C-9A1B-6B48-985E-46C6E57A7F9B}"/>
              </a:ext>
            </a:extLst>
          </p:cNvPr>
          <p:cNvGrpSpPr>
            <a:grpSpLocks noChangeAspect="1"/>
          </p:cNvGrpSpPr>
          <p:nvPr/>
        </p:nvGrpSpPr>
        <p:grpSpPr>
          <a:xfrm>
            <a:off x="137160" y="41178"/>
            <a:ext cx="6583680" cy="6931061"/>
            <a:chOff x="54831" y="88268"/>
            <a:chExt cx="6842491" cy="7203528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BB564FDC-29D1-B949-8C6B-CB1959FC32BC}"/>
                </a:ext>
              </a:extLst>
            </p:cNvPr>
            <p:cNvGrpSpPr/>
            <p:nvPr/>
          </p:nvGrpSpPr>
          <p:grpSpPr>
            <a:xfrm>
              <a:off x="54831" y="4453346"/>
              <a:ext cx="3352370" cy="1883536"/>
              <a:chOff x="3557469" y="420740"/>
              <a:chExt cx="3042857" cy="1709635"/>
            </a:xfrm>
          </p:grpSpPr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133ED642-6921-BB40-B905-800E28BE1E1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21549" r="32082"/>
              <a:stretch/>
            </p:blipFill>
            <p:spPr>
              <a:xfrm>
                <a:off x="3557469" y="420740"/>
                <a:ext cx="3042857" cy="1709635"/>
              </a:xfrm>
              <a:prstGeom prst="rect">
                <a:avLst/>
              </a:prstGeom>
            </p:spPr>
          </p:pic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53160F51-6335-D840-B9D9-0AF32235A922}"/>
                  </a:ext>
                </a:extLst>
              </p:cNvPr>
              <p:cNvSpPr/>
              <p:nvPr/>
            </p:nvSpPr>
            <p:spPr>
              <a:xfrm>
                <a:off x="4440786" y="844692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B9D6F41C-152E-9D4D-A20F-BB9F2049EDDF}"/>
                  </a:ext>
                </a:extLst>
              </p:cNvPr>
              <p:cNvSpPr/>
              <p:nvPr/>
            </p:nvSpPr>
            <p:spPr>
              <a:xfrm>
                <a:off x="4576786" y="841282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0CD989FB-DB75-3341-8C4A-CC4979F8CE3D}"/>
                  </a:ext>
                </a:extLst>
              </p:cNvPr>
              <p:cNvSpPr/>
              <p:nvPr/>
            </p:nvSpPr>
            <p:spPr>
              <a:xfrm>
                <a:off x="4716886" y="841282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8B568F32-98B7-164D-BDCF-0638757DE5DF}"/>
                  </a:ext>
                </a:extLst>
              </p:cNvPr>
              <p:cNvSpPr/>
              <p:nvPr/>
            </p:nvSpPr>
            <p:spPr>
              <a:xfrm>
                <a:off x="6017411" y="841282"/>
                <a:ext cx="84056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A3AE4B7C-AEEB-1642-8628-550806B970F2}"/>
                  </a:ext>
                </a:extLst>
              </p:cNvPr>
              <p:cNvSpPr/>
              <p:nvPr/>
            </p:nvSpPr>
            <p:spPr>
              <a:xfrm>
                <a:off x="4235635" y="1280025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D0734E0A-AD22-594C-8AE8-0AD429FAD085}"/>
                </a:ext>
              </a:extLst>
            </p:cNvPr>
            <p:cNvGrpSpPr/>
            <p:nvPr/>
          </p:nvGrpSpPr>
          <p:grpSpPr>
            <a:xfrm>
              <a:off x="3450798" y="4453346"/>
              <a:ext cx="3352371" cy="2838450"/>
              <a:chOff x="355180" y="399364"/>
              <a:chExt cx="3042857" cy="2576385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1907F66C-8036-F145-9575-517A8BBF6B6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8526" r="32082" b="42465"/>
              <a:stretch/>
            </p:blipFill>
            <p:spPr>
              <a:xfrm>
                <a:off x="355180" y="399364"/>
                <a:ext cx="3042857" cy="2576385"/>
              </a:xfrm>
              <a:prstGeom prst="rect">
                <a:avLst/>
              </a:prstGeom>
            </p:spPr>
          </p:pic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5B281960-1066-1540-969F-5DEB108E5D99}"/>
                  </a:ext>
                </a:extLst>
              </p:cNvPr>
              <p:cNvSpPr/>
              <p:nvPr/>
            </p:nvSpPr>
            <p:spPr>
              <a:xfrm>
                <a:off x="1267723" y="1702368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0063240B-845C-EF40-8103-F3144DD298D4}"/>
                  </a:ext>
                </a:extLst>
              </p:cNvPr>
              <p:cNvSpPr/>
              <p:nvPr/>
            </p:nvSpPr>
            <p:spPr>
              <a:xfrm>
                <a:off x="2336980" y="1702368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E3BED8D7-6F01-7C43-B0DE-2456B0C58806}"/>
                  </a:ext>
                </a:extLst>
              </p:cNvPr>
              <p:cNvSpPr/>
              <p:nvPr/>
            </p:nvSpPr>
            <p:spPr>
              <a:xfrm>
                <a:off x="2891225" y="1702368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1877396E-E7A2-6240-942E-3EBA4E0DD27F}"/>
                  </a:ext>
                </a:extLst>
              </p:cNvPr>
              <p:cNvSpPr/>
              <p:nvPr/>
            </p:nvSpPr>
            <p:spPr>
              <a:xfrm>
                <a:off x="3164986" y="1702368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1AAA8848-B7CC-2F47-904B-F5E76C5B2813}"/>
                  </a:ext>
                </a:extLst>
              </p:cNvPr>
              <p:cNvSpPr/>
              <p:nvPr/>
            </p:nvSpPr>
            <p:spPr>
              <a:xfrm>
                <a:off x="1681591" y="2138575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5B4E885B-86C3-D84A-8A8D-237DC13731AA}"/>
                  </a:ext>
                </a:extLst>
              </p:cNvPr>
              <p:cNvSpPr/>
              <p:nvPr/>
            </p:nvSpPr>
            <p:spPr>
              <a:xfrm>
                <a:off x="2822199" y="2138575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2B07DFFC-52C2-1343-8A28-A41A9D28151A}"/>
                  </a:ext>
                </a:extLst>
              </p:cNvPr>
              <p:cNvSpPr/>
              <p:nvPr/>
            </p:nvSpPr>
            <p:spPr>
              <a:xfrm>
                <a:off x="1165617" y="2582105"/>
                <a:ext cx="45719" cy="393643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6D88F85-9F94-E04E-B566-B8855257F295}"/>
                </a:ext>
              </a:extLst>
            </p:cNvPr>
            <p:cNvSpPr txBox="1"/>
            <p:nvPr/>
          </p:nvSpPr>
          <p:spPr>
            <a:xfrm>
              <a:off x="6589224" y="6818264"/>
              <a:ext cx="3080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…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F7C46AD8-10D4-7840-810D-20BDDCD3D4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35242"/>
            <a:stretch/>
          </p:blipFill>
          <p:spPr>
            <a:xfrm>
              <a:off x="82318" y="88268"/>
              <a:ext cx="6693363" cy="4032097"/>
            </a:xfrm>
            <a:prstGeom prst="rect">
              <a:avLst/>
            </a:prstGeom>
          </p:spPr>
        </p:pic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03C047E1-CFCA-FD4F-8369-86FC201B8798}"/>
              </a:ext>
            </a:extLst>
          </p:cNvPr>
          <p:cNvSpPr/>
          <p:nvPr/>
        </p:nvSpPr>
        <p:spPr>
          <a:xfrm>
            <a:off x="-32994" y="7075485"/>
            <a:ext cx="6923988" cy="20685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440"/>
              </a:lnSpc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4.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 Conservation of VEGF-A and Flk-1 Across Species Used for ELP-VEGF Development.  (a.) The crystal structure of human VEGF-A bound to Ig-like domains 2 and 3 of Flk-1 (VEGFR-2), solved by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ozzo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et al. [39], is shown with the contact residues highlighted.  The backbone of VEGFR-2 is shown in light grey, with residues that make contact with VEGF colored blue.  The backbone of VEGF-A is shown in dark grey, with residues that make contact with the receptor colored red.  Alignment of the primary amino acid sequences of VEGF-A (b.) and Flk-1 (c.) from human, mouse, rat, and swine were performed using T-Coffee, and contact residues identified from the crystal structure are highlighted in the blue boxes.  The C-terminus of the receptor sequence, containing the Ig-like domains that do not contact VEGF, the transmembrane domain, and the intracellular domain, are not shown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890E81F-08EB-D44B-B72F-4D470D9F7C90}"/>
              </a:ext>
            </a:extLst>
          </p:cNvPr>
          <p:cNvSpPr/>
          <p:nvPr/>
        </p:nvSpPr>
        <p:spPr>
          <a:xfrm>
            <a:off x="3461994" y="3980888"/>
            <a:ext cx="355862" cy="179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8BD0A3C-A2F8-174A-B8A9-65218089E225}"/>
              </a:ext>
            </a:extLst>
          </p:cNvPr>
          <p:cNvSpPr/>
          <p:nvPr/>
        </p:nvSpPr>
        <p:spPr>
          <a:xfrm>
            <a:off x="271081" y="3945326"/>
            <a:ext cx="355862" cy="2545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D45C0C2-377C-B84D-ABC4-01E820C8A40D}"/>
              </a:ext>
            </a:extLst>
          </p:cNvPr>
          <p:cNvSpPr/>
          <p:nvPr/>
        </p:nvSpPr>
        <p:spPr>
          <a:xfrm>
            <a:off x="279260" y="98582"/>
            <a:ext cx="355862" cy="25452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A08BC7-1205-6E47-AA69-918AF3FCF8B0}"/>
              </a:ext>
            </a:extLst>
          </p:cNvPr>
          <p:cNvSpPr txBox="1"/>
          <p:nvPr/>
        </p:nvSpPr>
        <p:spPr>
          <a:xfrm>
            <a:off x="271081" y="41178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5717682-7A11-F44C-8991-DFF61563A9CA}"/>
              </a:ext>
            </a:extLst>
          </p:cNvPr>
          <p:cNvSpPr txBox="1"/>
          <p:nvPr/>
        </p:nvSpPr>
        <p:spPr>
          <a:xfrm>
            <a:off x="217344" y="3833444"/>
            <a:ext cx="778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B8FA6E8-267E-4542-BF91-1006792A72F1}"/>
              </a:ext>
            </a:extLst>
          </p:cNvPr>
          <p:cNvSpPr txBox="1"/>
          <p:nvPr/>
        </p:nvSpPr>
        <p:spPr>
          <a:xfrm>
            <a:off x="3383703" y="3833444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2508002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483</TotalTime>
  <Words>531</Words>
  <Application>Microsoft Macintosh PowerPoint</Application>
  <PresentationFormat>Letter Paper (8.5x11 in)</PresentationFormat>
  <Paragraphs>38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e Bidwell</dc:creator>
  <cp:lastModifiedBy>Jamarius Waller</cp:lastModifiedBy>
  <cp:revision>93</cp:revision>
  <dcterms:created xsi:type="dcterms:W3CDTF">2020-03-17T18:04:13Z</dcterms:created>
  <dcterms:modified xsi:type="dcterms:W3CDTF">2021-02-15T15:26:14Z</dcterms:modified>
</cp:coreProperties>
</file>